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C15EC-9C91-4C60-9E17-96E93BB14B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7345E-3270-44A7-AE3D-97DE80BAEA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50B38-5A81-464F-A27B-AE9BAD8B96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9552A-D36F-4AB1-B87B-A2A2DEB8A4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794F6-4709-41F8-8D83-1AB59970E5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ECEB6-0886-44CF-AFF6-A7A5EEB6D1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477EF-D7D0-4E22-849D-71C29F2A7B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24FE1-1954-45D2-9E07-323DC6E458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2D3F7-BE81-49A8-AEF7-3EF68A98BD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959E7-A4D4-41D6-966F-6434E01D7E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4C8E6-4DBD-40E9-A0A6-C1B8C4253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C4D74-CEDE-474B-B824-E6FBAC7AD9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842F56-030B-40CF-98D1-A33FCBD184C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55760" y="5294160"/>
            <a:ext cx="2614680" cy="2417760"/>
          </a:xfrm>
          <a:prstGeom prst="rect">
            <a:avLst/>
          </a:prstGeom>
          <a:noFill/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425680" y="6440400"/>
            <a:ext cx="227160" cy="1271520"/>
            <a:chOff x="2425680" y="6440400"/>
            <a:chExt cx="227160" cy="1271520"/>
          </a:xfrm>
        </p:grpSpPr>
        <p:sp>
          <p:nvSpPr>
            <p:cNvPr id="43" name=""/>
            <p:cNvSpPr/>
            <p:nvPr/>
          </p:nvSpPr>
          <p:spPr>
            <a:xfrm>
              <a:off x="2425680" y="6440400"/>
              <a:ext cx="227160" cy="1271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425680" y="6440400"/>
              <a:ext cx="227160" cy="1271520"/>
            </a:xfrm>
            <a:prstGeom prst="rect">
              <a:avLst/>
            </a:prstGeom>
            <a:solidFill>
              <a:srgbClr val="000000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"/>
          <p:cNvGrpSpPr/>
          <p:nvPr/>
        </p:nvGrpSpPr>
        <p:grpSpPr>
          <a:xfrm>
            <a:off x="3683160" y="7058160"/>
            <a:ext cx="234720" cy="653760"/>
            <a:chOff x="3683160" y="7058160"/>
            <a:chExt cx="234720" cy="653760"/>
          </a:xfrm>
        </p:grpSpPr>
        <p:sp>
          <p:nvSpPr>
            <p:cNvPr id="46" name=""/>
            <p:cNvSpPr/>
            <p:nvPr/>
          </p:nvSpPr>
          <p:spPr>
            <a:xfrm>
              <a:off x="3683160" y="7058160"/>
              <a:ext cx="234720" cy="65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683160" y="7058160"/>
              <a:ext cx="234720" cy="653760"/>
            </a:xfrm>
            <a:prstGeom prst="rect">
              <a:avLst/>
            </a:prstGeom>
            <a:solidFill>
              <a:srgbClr val="000000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"/>
          <p:cNvGrpSpPr/>
          <p:nvPr/>
        </p:nvGrpSpPr>
        <p:grpSpPr>
          <a:xfrm>
            <a:off x="2652840" y="6218280"/>
            <a:ext cx="233280" cy="1493640"/>
            <a:chOff x="2652840" y="6218280"/>
            <a:chExt cx="233280" cy="1493640"/>
          </a:xfrm>
        </p:grpSpPr>
        <p:sp>
          <p:nvSpPr>
            <p:cNvPr id="49" name=""/>
            <p:cNvSpPr/>
            <p:nvPr/>
          </p:nvSpPr>
          <p:spPr>
            <a:xfrm>
              <a:off x="2652840" y="6218280"/>
              <a:ext cx="233280" cy="14936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652840" y="6218280"/>
              <a:ext cx="233280" cy="1493640"/>
            </a:xfrm>
            <a:prstGeom prst="rect">
              <a:avLst/>
            </a:prstGeom>
            <a:solidFill>
              <a:srgbClr val="808080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"/>
          <p:cNvGrpSpPr/>
          <p:nvPr/>
        </p:nvGrpSpPr>
        <p:grpSpPr>
          <a:xfrm>
            <a:off x="3917880" y="6632640"/>
            <a:ext cx="225360" cy="1079280"/>
            <a:chOff x="3917880" y="6632640"/>
            <a:chExt cx="225360" cy="1079280"/>
          </a:xfrm>
        </p:grpSpPr>
        <p:sp>
          <p:nvSpPr>
            <p:cNvPr id="52" name=""/>
            <p:cNvSpPr/>
            <p:nvPr/>
          </p:nvSpPr>
          <p:spPr>
            <a:xfrm>
              <a:off x="3917880" y="6632640"/>
              <a:ext cx="225360" cy="10792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917880" y="6632640"/>
              <a:ext cx="225360" cy="1079280"/>
            </a:xfrm>
            <a:prstGeom prst="rect">
              <a:avLst/>
            </a:prstGeom>
            <a:solidFill>
              <a:srgbClr val="808080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"/>
          <p:cNvGrpSpPr/>
          <p:nvPr/>
        </p:nvGrpSpPr>
        <p:grpSpPr>
          <a:xfrm>
            <a:off x="2886120" y="7216920"/>
            <a:ext cx="228600" cy="495000"/>
            <a:chOff x="2886120" y="7216920"/>
            <a:chExt cx="228600" cy="495000"/>
          </a:xfrm>
        </p:grpSpPr>
        <p:sp>
          <p:nvSpPr>
            <p:cNvPr id="55" name=""/>
            <p:cNvSpPr/>
            <p:nvPr/>
          </p:nvSpPr>
          <p:spPr>
            <a:xfrm>
              <a:off x="2886120" y="7216920"/>
              <a:ext cx="228600" cy="49500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886120" y="7216920"/>
              <a:ext cx="228600" cy="495000"/>
            </a:xfrm>
            <a:prstGeom prst="rect">
              <a:avLst/>
            </a:prstGeom>
            <a:solidFill>
              <a:srgbClr val="dddddd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"/>
          <p:cNvGrpSpPr/>
          <p:nvPr/>
        </p:nvGrpSpPr>
        <p:grpSpPr>
          <a:xfrm>
            <a:off x="4143240" y="7402680"/>
            <a:ext cx="235080" cy="309240"/>
            <a:chOff x="4143240" y="7402680"/>
            <a:chExt cx="235080" cy="309240"/>
          </a:xfrm>
        </p:grpSpPr>
        <p:sp>
          <p:nvSpPr>
            <p:cNvPr id="58" name=""/>
            <p:cNvSpPr/>
            <p:nvPr/>
          </p:nvSpPr>
          <p:spPr>
            <a:xfrm>
              <a:off x="4143240" y="7402680"/>
              <a:ext cx="235080" cy="30924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143240" y="7402680"/>
              <a:ext cx="235080" cy="309240"/>
            </a:xfrm>
            <a:prstGeom prst="rect">
              <a:avLst/>
            </a:prstGeom>
            <a:solidFill>
              <a:srgbClr val="dddddd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"/>
          <p:cNvGrpSpPr/>
          <p:nvPr/>
        </p:nvGrpSpPr>
        <p:grpSpPr>
          <a:xfrm>
            <a:off x="3114720" y="7002360"/>
            <a:ext cx="225360" cy="709560"/>
            <a:chOff x="3114720" y="7002360"/>
            <a:chExt cx="225360" cy="709560"/>
          </a:xfrm>
        </p:grpSpPr>
        <p:sp>
          <p:nvSpPr>
            <p:cNvPr id="61" name=""/>
            <p:cNvSpPr/>
            <p:nvPr/>
          </p:nvSpPr>
          <p:spPr>
            <a:xfrm>
              <a:off x="3114720" y="7002360"/>
              <a:ext cx="225360" cy="709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114720" y="7002360"/>
              <a:ext cx="225360" cy="709560"/>
            </a:xfrm>
            <a:prstGeom prst="rect">
              <a:avLst/>
            </a:prstGeom>
            <a:solidFill>
              <a:srgbClr val="ffffff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"/>
          <p:cNvGrpSpPr/>
          <p:nvPr/>
        </p:nvGrpSpPr>
        <p:grpSpPr>
          <a:xfrm>
            <a:off x="4378320" y="7161120"/>
            <a:ext cx="225360" cy="550800"/>
            <a:chOff x="4378320" y="7161120"/>
            <a:chExt cx="225360" cy="550800"/>
          </a:xfrm>
        </p:grpSpPr>
        <p:sp>
          <p:nvSpPr>
            <p:cNvPr id="64" name=""/>
            <p:cNvSpPr/>
            <p:nvPr/>
          </p:nvSpPr>
          <p:spPr>
            <a:xfrm>
              <a:off x="4378320" y="7161120"/>
              <a:ext cx="225360" cy="550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378320" y="7161120"/>
              <a:ext cx="225360" cy="550800"/>
            </a:xfrm>
            <a:prstGeom prst="rect">
              <a:avLst/>
            </a:prstGeom>
            <a:solidFill>
              <a:srgbClr val="ffffff"/>
            </a:solidFill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 flipV="1">
            <a:off x="2536920" y="6163920"/>
            <a:ext cx="0" cy="27612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509920" y="616428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3801960" y="6804000"/>
            <a:ext cx="0" cy="25416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773520" y="6804000"/>
            <a:ext cx="601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536920" y="6440400"/>
            <a:ext cx="0" cy="26676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509920" y="670716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801960" y="7058160"/>
            <a:ext cx="0" cy="25560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773520" y="7313760"/>
            <a:ext cx="601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2770200" y="5765400"/>
            <a:ext cx="0" cy="45252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38520" y="575784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4027320" y="6465600"/>
            <a:ext cx="0" cy="16668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000680" y="6465960"/>
            <a:ext cx="6156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770200" y="6218280"/>
            <a:ext cx="0" cy="45540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43200" y="667368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027320" y="6632640"/>
            <a:ext cx="0" cy="15876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000680" y="6791400"/>
            <a:ext cx="6156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2997360" y="7098840"/>
            <a:ext cx="0" cy="11772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968560" y="709920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4260960" y="7278840"/>
            <a:ext cx="0" cy="12384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233960" y="727884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997360" y="7216920"/>
            <a:ext cx="0" cy="11592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968560" y="733284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260960" y="7402680"/>
            <a:ext cx="0" cy="12204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233960" y="752472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3222720" y="6723000"/>
            <a:ext cx="0" cy="27936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197160" y="6723000"/>
            <a:ext cx="6048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>
            <a:off x="4487760" y="7063920"/>
            <a:ext cx="0" cy="9684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60760" y="706428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222720" y="7002360"/>
            <a:ext cx="0" cy="28260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197160" y="7284960"/>
            <a:ext cx="6048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487760" y="7161120"/>
            <a:ext cx="0" cy="9072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460760" y="7251840"/>
            <a:ext cx="6192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255760" y="5545080"/>
            <a:ext cx="0" cy="216684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212920" y="771192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212920" y="749952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212920" y="727884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212920" y="706428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212920" y="684684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212920" y="663264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212920" y="641196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212920" y="619920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212920" y="597852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212920" y="576576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212920" y="5545080"/>
            <a:ext cx="428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2255760" y="7711560"/>
            <a:ext cx="0" cy="4140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3511440" y="7711560"/>
            <a:ext cx="0" cy="4140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117520" y="76438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978920" y="74296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978920" y="72090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978920" y="69962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978920" y="67755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912320" y="656280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912320" y="634356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912320" y="612936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912320" y="590868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912320" y="569448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912320" y="547704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975120" y="7756560"/>
            <a:ext cx="42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da1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"/>
          <p:cNvGrpSpPr/>
          <p:nvPr/>
        </p:nvGrpSpPr>
        <p:grpSpPr>
          <a:xfrm>
            <a:off x="2257560" y="5294160"/>
            <a:ext cx="2612880" cy="370080"/>
            <a:chOff x="2257560" y="5294160"/>
            <a:chExt cx="2612880" cy="370080"/>
          </a:xfrm>
        </p:grpSpPr>
        <p:sp>
          <p:nvSpPr>
            <p:cNvPr id="125" name=""/>
            <p:cNvSpPr/>
            <p:nvPr/>
          </p:nvSpPr>
          <p:spPr>
            <a:xfrm>
              <a:off x="2257560" y="5294160"/>
              <a:ext cx="2612880" cy="370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257560" y="5294160"/>
              <a:ext cx="2612880" cy="370080"/>
            </a:xfrm>
            <a:prstGeom prst="rect">
              <a:avLst/>
            </a:prstGeom>
            <a:noFill/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7" name=""/>
          <p:cNvGrpSpPr/>
          <p:nvPr/>
        </p:nvGrpSpPr>
        <p:grpSpPr>
          <a:xfrm>
            <a:off x="2303640" y="5348160"/>
            <a:ext cx="74520" cy="76320"/>
            <a:chOff x="2303640" y="5348160"/>
            <a:chExt cx="74520" cy="76320"/>
          </a:xfrm>
        </p:grpSpPr>
        <p:sp>
          <p:nvSpPr>
            <p:cNvPr id="128" name=""/>
            <p:cNvSpPr/>
            <p:nvPr/>
          </p:nvSpPr>
          <p:spPr>
            <a:xfrm>
              <a:off x="2303640" y="5348160"/>
              <a:ext cx="74520" cy="76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303640" y="5348160"/>
              <a:ext cx="74520" cy="76320"/>
            </a:xfrm>
            <a:prstGeom prst="rect">
              <a:avLst/>
            </a:prstGeom>
            <a:solidFill>
              <a:srgbClr val="000000"/>
            </a:solidFill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"/>
          <p:cNvSpPr/>
          <p:nvPr/>
        </p:nvSpPr>
        <p:spPr>
          <a:xfrm>
            <a:off x="2417040" y="5313240"/>
            <a:ext cx="1058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</a:rPr>
              <a:t>Ca Sucrose (30 mM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1" name=""/>
          <p:cNvGrpSpPr/>
          <p:nvPr/>
        </p:nvGrpSpPr>
        <p:grpSpPr>
          <a:xfrm>
            <a:off x="3597120" y="5359320"/>
            <a:ext cx="76320" cy="76320"/>
            <a:chOff x="3597120" y="5359320"/>
            <a:chExt cx="76320" cy="76320"/>
          </a:xfrm>
        </p:grpSpPr>
        <p:sp>
          <p:nvSpPr>
            <p:cNvPr id="132" name=""/>
            <p:cNvSpPr/>
            <p:nvPr/>
          </p:nvSpPr>
          <p:spPr>
            <a:xfrm>
              <a:off x="3597120" y="5359320"/>
              <a:ext cx="76320" cy="763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597120" y="5359320"/>
              <a:ext cx="76320" cy="76320"/>
            </a:xfrm>
            <a:prstGeom prst="rect">
              <a:avLst/>
            </a:prstGeom>
            <a:solidFill>
              <a:srgbClr val="808080"/>
            </a:solidFill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"/>
          <p:cNvSpPr/>
          <p:nvPr/>
        </p:nvSpPr>
        <p:spPr>
          <a:xfrm>
            <a:off x="3717000" y="5324400"/>
            <a:ext cx="1122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</a:rPr>
              <a:t>Ca Sucrose (175 mM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"/>
          <p:cNvGrpSpPr/>
          <p:nvPr/>
        </p:nvGrpSpPr>
        <p:grpSpPr>
          <a:xfrm>
            <a:off x="2303640" y="5526000"/>
            <a:ext cx="74520" cy="74880"/>
            <a:chOff x="2303640" y="5526000"/>
            <a:chExt cx="74520" cy="74880"/>
          </a:xfrm>
        </p:grpSpPr>
        <p:sp>
          <p:nvSpPr>
            <p:cNvPr id="136" name=""/>
            <p:cNvSpPr/>
            <p:nvPr/>
          </p:nvSpPr>
          <p:spPr>
            <a:xfrm>
              <a:off x="2303640" y="5526000"/>
              <a:ext cx="74520" cy="7488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303640" y="5526000"/>
              <a:ext cx="74520" cy="74880"/>
            </a:xfrm>
            <a:prstGeom prst="rect">
              <a:avLst/>
            </a:prstGeom>
            <a:solidFill>
              <a:srgbClr val="dddddd"/>
            </a:solidFill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8" name=""/>
          <p:cNvSpPr/>
          <p:nvPr/>
        </p:nvSpPr>
        <p:spPr>
          <a:xfrm>
            <a:off x="2417040" y="5489640"/>
            <a:ext cx="1058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</a:rPr>
              <a:t>Cb Sucrose (30 mM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9" name=""/>
          <p:cNvGrpSpPr/>
          <p:nvPr/>
        </p:nvGrpSpPr>
        <p:grpSpPr>
          <a:xfrm>
            <a:off x="3597120" y="5537160"/>
            <a:ext cx="76320" cy="74520"/>
            <a:chOff x="3597120" y="5537160"/>
            <a:chExt cx="76320" cy="74520"/>
          </a:xfrm>
        </p:grpSpPr>
        <p:sp>
          <p:nvSpPr>
            <p:cNvPr id="140" name=""/>
            <p:cNvSpPr/>
            <p:nvPr/>
          </p:nvSpPr>
          <p:spPr>
            <a:xfrm>
              <a:off x="3597120" y="5537160"/>
              <a:ext cx="76320" cy="74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597120" y="5537160"/>
              <a:ext cx="76320" cy="74520"/>
            </a:xfrm>
            <a:prstGeom prst="rect">
              <a:avLst/>
            </a:prstGeom>
            <a:solidFill>
              <a:srgbClr val="ffffff"/>
            </a:solidFill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2" name=""/>
          <p:cNvSpPr/>
          <p:nvPr/>
        </p:nvSpPr>
        <p:spPr>
          <a:xfrm>
            <a:off x="3717000" y="5500800"/>
            <a:ext cx="1122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</a:rPr>
              <a:t>Cb Sucrose (175 mM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214720" y="5295960"/>
            <a:ext cx="41040" cy="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915560" y="52135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16200000">
            <a:off x="1134720" y="6495120"/>
            <a:ext cx="136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Concentration (mg/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708640" y="775476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l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" descr=""/>
          <p:cNvPicPr/>
          <p:nvPr/>
        </p:nvPicPr>
        <p:blipFill>
          <a:blip r:embed="rId1"/>
          <a:stretch/>
        </p:blipFill>
        <p:spPr>
          <a:xfrm>
            <a:off x="1989000" y="2583000"/>
            <a:ext cx="1440000" cy="1152360"/>
          </a:xfrm>
          <a:prstGeom prst="rect">
            <a:avLst/>
          </a:prstGeom>
          <a:ln w="0">
            <a:noFill/>
          </a:ln>
        </p:spPr>
      </p:pic>
      <p:pic>
        <p:nvPicPr>
          <p:cNvPr id="148" name="" descr=""/>
          <p:cNvPicPr/>
          <p:nvPr/>
        </p:nvPicPr>
        <p:blipFill>
          <a:blip r:embed="rId2"/>
          <a:stretch/>
        </p:blipFill>
        <p:spPr>
          <a:xfrm>
            <a:off x="3425760" y="2583000"/>
            <a:ext cx="1440000" cy="1152360"/>
          </a:xfrm>
          <a:prstGeom prst="rect">
            <a:avLst/>
          </a:prstGeom>
          <a:ln w="0">
            <a:noFill/>
          </a:ln>
        </p:spPr>
      </p:pic>
      <p:pic>
        <p:nvPicPr>
          <p:cNvPr id="149" name="" descr=""/>
          <p:cNvPicPr/>
          <p:nvPr/>
        </p:nvPicPr>
        <p:blipFill>
          <a:blip r:embed="rId3"/>
          <a:stretch/>
        </p:blipFill>
        <p:spPr>
          <a:xfrm>
            <a:off x="2001960" y="3732120"/>
            <a:ext cx="1439640" cy="1152720"/>
          </a:xfrm>
          <a:prstGeom prst="rect">
            <a:avLst/>
          </a:prstGeom>
          <a:ln w="0">
            <a:noFill/>
          </a:ln>
        </p:spPr>
      </p:pic>
      <p:pic>
        <p:nvPicPr>
          <p:cNvPr id="150" name="" descr=""/>
          <p:cNvPicPr/>
          <p:nvPr/>
        </p:nvPicPr>
        <p:blipFill>
          <a:blip r:embed="rId4"/>
          <a:stretch/>
        </p:blipFill>
        <p:spPr>
          <a:xfrm>
            <a:off x="3422520" y="3728880"/>
            <a:ext cx="1440000" cy="1152720"/>
          </a:xfrm>
          <a:prstGeom prst="rect">
            <a:avLst/>
          </a:prstGeom>
          <a:ln w="0">
            <a:noFill/>
          </a:ln>
        </p:spPr>
      </p:pic>
      <p:sp>
        <p:nvSpPr>
          <p:cNvPr id="151" name=""/>
          <p:cNvSpPr/>
          <p:nvPr/>
        </p:nvSpPr>
        <p:spPr>
          <a:xfrm>
            <a:off x="2876760" y="262404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ol-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741760" y="373680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Arial"/>
              </a:rPr>
              <a:t>mda1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275360" y="256068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ol-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124160" y="373680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Arial"/>
              </a:rPr>
              <a:t>mda1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921760" y="2098800"/>
            <a:ext cx="113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Sucrose (m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468880" y="2338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959280" y="23385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5"/>
          <p:cNvSpPr/>
          <p:nvPr/>
        </p:nvSpPr>
        <p:spPr>
          <a:xfrm>
            <a:off x="2011320" y="611280"/>
            <a:ext cx="283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996560" y="260028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431880" y="260028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995480" y="37288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430440" y="37288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899720" y="48816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973600" y="646596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"/>
          <p:cNvGrpSpPr/>
          <p:nvPr/>
        </p:nvGrpSpPr>
        <p:grpSpPr>
          <a:xfrm>
            <a:off x="2954160" y="6608880"/>
            <a:ext cx="269640" cy="42840"/>
            <a:chOff x="2954160" y="6608880"/>
            <a:chExt cx="269640" cy="42840"/>
          </a:xfrm>
        </p:grpSpPr>
        <p:sp>
          <p:nvSpPr>
            <p:cNvPr id="166" name=""/>
            <p:cNvSpPr/>
            <p:nvPr/>
          </p:nvSpPr>
          <p:spPr>
            <a:xfrm>
              <a:off x="2959560" y="6608880"/>
              <a:ext cx="26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flipH="1">
              <a:off x="2954160" y="660888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flipH="1">
              <a:off x="3222360" y="660888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9" name=""/>
          <p:cNvSpPr/>
          <p:nvPr/>
        </p:nvSpPr>
        <p:spPr>
          <a:xfrm>
            <a:off x="3771000" y="617868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0" name=""/>
          <p:cNvGrpSpPr/>
          <p:nvPr/>
        </p:nvGrpSpPr>
        <p:grpSpPr>
          <a:xfrm>
            <a:off x="3773520" y="6321600"/>
            <a:ext cx="269640" cy="42840"/>
            <a:chOff x="3773520" y="6321600"/>
            <a:chExt cx="269640" cy="42840"/>
          </a:xfrm>
        </p:grpSpPr>
        <p:sp>
          <p:nvSpPr>
            <p:cNvPr id="171" name=""/>
            <p:cNvSpPr/>
            <p:nvPr/>
          </p:nvSpPr>
          <p:spPr>
            <a:xfrm>
              <a:off x="3778920" y="6321600"/>
              <a:ext cx="26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flipH="1">
              <a:off x="3773520" y="632160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H="1">
              <a:off x="4041720" y="632160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4" name=""/>
          <p:cNvSpPr/>
          <p:nvPr/>
        </p:nvSpPr>
        <p:spPr>
          <a:xfrm>
            <a:off x="4217040" y="683244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"/>
          <p:cNvGrpSpPr/>
          <p:nvPr/>
        </p:nvGrpSpPr>
        <p:grpSpPr>
          <a:xfrm>
            <a:off x="4219560" y="6975360"/>
            <a:ext cx="269640" cy="42840"/>
            <a:chOff x="4219560" y="6975360"/>
            <a:chExt cx="269640" cy="42840"/>
          </a:xfrm>
        </p:grpSpPr>
        <p:sp>
          <p:nvSpPr>
            <p:cNvPr id="176" name=""/>
            <p:cNvSpPr/>
            <p:nvPr/>
          </p:nvSpPr>
          <p:spPr>
            <a:xfrm>
              <a:off x="4224960" y="6975360"/>
              <a:ext cx="26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H="1">
              <a:off x="4219560" y="697536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H="1">
              <a:off x="4487760" y="697536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9" name=""/>
          <p:cNvSpPr/>
          <p:nvPr/>
        </p:nvSpPr>
        <p:spPr>
          <a:xfrm>
            <a:off x="2141640" y="4756320"/>
            <a:ext cx="69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135160" y="3603600"/>
            <a:ext cx="69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568680" y="3603600"/>
            <a:ext cx="69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565440" y="4753080"/>
            <a:ext cx="69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01T16:55:56Z</dcterms:created>
  <dc:creator>vquesada</dc:creator>
  <dc:description/>
  <dc:language>en-US</dc:language>
  <cp:lastModifiedBy>vquesada</cp:lastModifiedBy>
  <dcterms:modified xsi:type="dcterms:W3CDTF">2012-07-03T13:47:55Z</dcterms:modified>
  <cp:revision>9</cp:revision>
  <dc:subject/>
  <dc:title>Diapositiva 1</dc:title>
</cp:coreProperties>
</file>